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90" r:id="rId2"/>
    <p:sldId id="289" r:id="rId3"/>
    <p:sldId id="291" r:id="rId4"/>
    <p:sldId id="285" r:id="rId5"/>
  </p:sldIdLst>
  <p:sldSz cx="46080363" cy="46080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00"/>
    <a:srgbClr val="00D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5ECFD9-0DCB-4169-AF29-57A3A50B9109}" v="28" dt="2024-08-02T02:07:12.4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3" autoAdjust="0"/>
    <p:restoredTop sz="96509" autoAdjust="0"/>
  </p:normalViewPr>
  <p:slideViewPr>
    <p:cSldViewPr snapToGrid="0">
      <p:cViewPr varScale="1">
        <p:scale>
          <a:sx n="16" d="100"/>
          <a:sy n="16" d="100"/>
        </p:scale>
        <p:origin x="178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ohua xie" userId="28ac0b58a72c0b90" providerId="LiveId" clId="{EE5ECFD9-0DCB-4169-AF29-57A3A50B9109}"/>
    <pc:docChg chg="custSel modSld">
      <pc:chgData name="shaohua xie" userId="28ac0b58a72c0b90" providerId="LiveId" clId="{EE5ECFD9-0DCB-4169-AF29-57A3A50B9109}" dt="2024-08-02T02:07:14.396" v="188" actId="20577"/>
      <pc:docMkLst>
        <pc:docMk/>
      </pc:docMkLst>
      <pc:sldChg chg="addSp delSp modSp mod">
        <pc:chgData name="shaohua xie" userId="28ac0b58a72c0b90" providerId="LiveId" clId="{EE5ECFD9-0DCB-4169-AF29-57A3A50B9109}" dt="2024-08-02T02:07:14.396" v="188" actId="20577"/>
        <pc:sldMkLst>
          <pc:docMk/>
          <pc:sldMk cId="155154164" sldId="285"/>
        </pc:sldMkLst>
        <pc:spChg chg="add mod">
          <ac:chgData name="shaohua xie" userId="28ac0b58a72c0b90" providerId="LiveId" clId="{EE5ECFD9-0DCB-4169-AF29-57A3A50B9109}" dt="2024-08-02T02:04:56.027" v="136" actId="1038"/>
          <ac:spMkLst>
            <pc:docMk/>
            <pc:sldMk cId="155154164" sldId="285"/>
            <ac:spMk id="55" creationId="{E92D88DA-EFB0-4CE6-5480-226E5B2563D8}"/>
          </ac:spMkLst>
        </pc:spChg>
        <pc:spChg chg="add mod">
          <ac:chgData name="shaohua xie" userId="28ac0b58a72c0b90" providerId="LiveId" clId="{EE5ECFD9-0DCB-4169-AF29-57A3A50B9109}" dt="2024-08-02T02:05:01.467" v="138" actId="20577"/>
          <ac:spMkLst>
            <pc:docMk/>
            <pc:sldMk cId="155154164" sldId="285"/>
            <ac:spMk id="56" creationId="{35E94D7C-6B51-A7DC-4722-7CA1888F11F5}"/>
          </ac:spMkLst>
        </pc:spChg>
        <pc:spChg chg="add mod">
          <ac:chgData name="shaohua xie" userId="28ac0b58a72c0b90" providerId="LiveId" clId="{EE5ECFD9-0DCB-4169-AF29-57A3A50B9109}" dt="2024-08-02T02:05:09.227" v="140" actId="20577"/>
          <ac:spMkLst>
            <pc:docMk/>
            <pc:sldMk cId="155154164" sldId="285"/>
            <ac:spMk id="57" creationId="{683F71FA-1B5F-B4C4-B9CA-6E55E8BDA723}"/>
          </ac:spMkLst>
        </pc:spChg>
        <pc:spChg chg="add mod">
          <ac:chgData name="shaohua xie" userId="28ac0b58a72c0b90" providerId="LiveId" clId="{EE5ECFD9-0DCB-4169-AF29-57A3A50B9109}" dt="2024-08-02T02:05:17.867" v="144" actId="20577"/>
          <ac:spMkLst>
            <pc:docMk/>
            <pc:sldMk cId="155154164" sldId="285"/>
            <ac:spMk id="58" creationId="{9F9FBC9C-1734-C5C8-5641-47392F9946D9}"/>
          </ac:spMkLst>
        </pc:spChg>
        <pc:spChg chg="add mod">
          <ac:chgData name="shaohua xie" userId="28ac0b58a72c0b90" providerId="LiveId" clId="{EE5ECFD9-0DCB-4169-AF29-57A3A50B9109}" dt="2024-08-02T02:05:29.179" v="151" actId="1035"/>
          <ac:spMkLst>
            <pc:docMk/>
            <pc:sldMk cId="155154164" sldId="285"/>
            <ac:spMk id="59" creationId="{73D5846B-2193-4B55-6A18-190B96ADD754}"/>
          </ac:spMkLst>
        </pc:spChg>
        <pc:spChg chg="add mod">
          <ac:chgData name="shaohua xie" userId="28ac0b58a72c0b90" providerId="LiveId" clId="{EE5ECFD9-0DCB-4169-AF29-57A3A50B9109}" dt="2024-08-02T02:05:34.332" v="153" actId="20577"/>
          <ac:spMkLst>
            <pc:docMk/>
            <pc:sldMk cId="155154164" sldId="285"/>
            <ac:spMk id="60" creationId="{2ADBDF15-F3DE-5361-A442-59817ADAD9DA}"/>
          </ac:spMkLst>
        </pc:spChg>
        <pc:spChg chg="add mod">
          <ac:chgData name="shaohua xie" userId="28ac0b58a72c0b90" providerId="LiveId" clId="{EE5ECFD9-0DCB-4169-AF29-57A3A50B9109}" dt="2024-08-02T02:05:39.691" v="155" actId="20577"/>
          <ac:spMkLst>
            <pc:docMk/>
            <pc:sldMk cId="155154164" sldId="285"/>
            <ac:spMk id="61" creationId="{310B6007-A193-D650-E802-66F30A7529DE}"/>
          </ac:spMkLst>
        </pc:spChg>
        <pc:spChg chg="add mod">
          <ac:chgData name="shaohua xie" userId="28ac0b58a72c0b90" providerId="LiveId" clId="{EE5ECFD9-0DCB-4169-AF29-57A3A50B9109}" dt="2024-08-02T02:05:48.075" v="160" actId="1036"/>
          <ac:spMkLst>
            <pc:docMk/>
            <pc:sldMk cId="155154164" sldId="285"/>
            <ac:spMk id="62" creationId="{705D8703-F104-3550-9D4E-1755C13E7584}"/>
          </ac:spMkLst>
        </pc:spChg>
        <pc:spChg chg="add del mod">
          <ac:chgData name="shaohua xie" userId="28ac0b58a72c0b90" providerId="LiveId" clId="{EE5ECFD9-0DCB-4169-AF29-57A3A50B9109}" dt="2024-08-02T02:05:59.742" v="165" actId="478"/>
          <ac:spMkLst>
            <pc:docMk/>
            <pc:sldMk cId="155154164" sldId="285"/>
            <ac:spMk id="63" creationId="{EA000E26-E4F0-09D2-F865-5663B674218C}"/>
          </ac:spMkLst>
        </pc:spChg>
        <pc:spChg chg="add mod">
          <ac:chgData name="shaohua xie" userId="28ac0b58a72c0b90" providerId="LiveId" clId="{EE5ECFD9-0DCB-4169-AF29-57A3A50B9109}" dt="2024-08-02T02:06:12.604" v="171" actId="1036"/>
          <ac:spMkLst>
            <pc:docMk/>
            <pc:sldMk cId="155154164" sldId="285"/>
            <ac:spMk id="64" creationId="{33AE4E67-DFA7-4346-7F5A-4DAB9C53BFCB}"/>
          </ac:spMkLst>
        </pc:spChg>
        <pc:spChg chg="add mod">
          <ac:chgData name="shaohua xie" userId="28ac0b58a72c0b90" providerId="LiveId" clId="{EE5ECFD9-0DCB-4169-AF29-57A3A50B9109}" dt="2024-08-02T02:06:22.205" v="174" actId="14100"/>
          <ac:spMkLst>
            <pc:docMk/>
            <pc:sldMk cId="155154164" sldId="285"/>
            <ac:spMk id="65" creationId="{4D098C75-C31D-9732-6B2A-ACCB4BB65175}"/>
          </ac:spMkLst>
        </pc:spChg>
        <pc:spChg chg="add mod">
          <ac:chgData name="shaohua xie" userId="28ac0b58a72c0b90" providerId="LiveId" clId="{EE5ECFD9-0DCB-4169-AF29-57A3A50B9109}" dt="2024-08-02T02:06:57.019" v="181" actId="20577"/>
          <ac:spMkLst>
            <pc:docMk/>
            <pc:sldMk cId="155154164" sldId="285"/>
            <ac:spMk id="66" creationId="{AB6E9903-5DB7-CF6F-990B-3D846F6D9970}"/>
          </ac:spMkLst>
        </pc:spChg>
        <pc:spChg chg="add mod">
          <ac:chgData name="shaohua xie" userId="28ac0b58a72c0b90" providerId="LiveId" clId="{EE5ECFD9-0DCB-4169-AF29-57A3A50B9109}" dt="2024-08-02T02:06:59.915" v="184" actId="20577"/>
          <ac:spMkLst>
            <pc:docMk/>
            <pc:sldMk cId="155154164" sldId="285"/>
            <ac:spMk id="67" creationId="{AAEAA197-DFEC-337A-DD4B-59F01241F8A3}"/>
          </ac:spMkLst>
        </pc:spChg>
        <pc:spChg chg="add mod">
          <ac:chgData name="shaohua xie" userId="28ac0b58a72c0b90" providerId="LiveId" clId="{EE5ECFD9-0DCB-4169-AF29-57A3A50B9109}" dt="2024-08-02T02:07:14.396" v="188" actId="20577"/>
          <ac:spMkLst>
            <pc:docMk/>
            <pc:sldMk cId="155154164" sldId="285"/>
            <ac:spMk id="68" creationId="{5485AFCB-FAA2-931A-767B-39C1782AAC96}"/>
          </ac:spMkLst>
        </pc:sp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4" creationId="{5121BE6D-2148-3881-59C2-FD378D10B3FC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6" creationId="{FF0A4115-506B-0579-A43C-29696DE9371F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8" creationId="{7B4B5C05-44C4-E7D7-D084-A74533BD3EA9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10" creationId="{277EBF6A-C25E-449B-F8EA-E8FDED6C3035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12" creationId="{15971FF5-39B1-81D1-7F46-D8FC26A4CC93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14" creationId="{CF8A77D1-3719-4A6E-2498-E48BA99494DA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16" creationId="{6246799E-9E9B-E59C-E41E-CFA90C876935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18" creationId="{33F575AA-412A-7BBF-FBA4-B86FAE6ACB11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20" creationId="{EC04EEE3-1763-CF5F-2B0F-C0F2C096DA26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22" creationId="{2BBAEEDB-9EDC-99EF-E003-1BA40E902EF6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24" creationId="{9CB20948-F4DE-0671-9D18-4059743A0858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26" creationId="{6C7CED37-27D3-E69C-161C-BE871828B909}"/>
          </ac:picMkLst>
        </pc:picChg>
        <pc:picChg chg="add del mod">
          <ac:chgData name="shaohua xie" userId="28ac0b58a72c0b90" providerId="LiveId" clId="{EE5ECFD9-0DCB-4169-AF29-57A3A50B9109}" dt="2024-08-02T01:50:49.865" v="29" actId="478"/>
          <ac:picMkLst>
            <pc:docMk/>
            <pc:sldMk cId="155154164" sldId="285"/>
            <ac:picMk id="28" creationId="{D5432580-6653-1051-8C58-B37561BD5F54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30" creationId="{59C89845-798A-09B2-636D-96C570372389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32" creationId="{9B2A621F-3E85-25C9-B902-EAD3B606141C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34" creationId="{6565FAF1-CE6E-8BE4-BC0B-BE8F30085067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36" creationId="{09F7F587-008D-95B1-B0EB-5F891939A2EE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38" creationId="{DC141AD5-E514-BE6E-093D-972466DE85CF}"/>
          </ac:picMkLst>
        </pc:picChg>
        <pc:picChg chg="add mod">
          <ac:chgData name="shaohua xie" userId="28ac0b58a72c0b90" providerId="LiveId" clId="{EE5ECFD9-0DCB-4169-AF29-57A3A50B9109}" dt="2024-08-02T02:05:55.109" v="163" actId="1076"/>
          <ac:picMkLst>
            <pc:docMk/>
            <pc:sldMk cId="155154164" sldId="285"/>
            <ac:picMk id="40" creationId="{B5603011-795A-5166-B749-B4EAF70DB515}"/>
          </ac:picMkLst>
        </pc:picChg>
        <pc:picChg chg="add mod">
          <ac:chgData name="shaohua xie" userId="28ac0b58a72c0b90" providerId="LiveId" clId="{EE5ECFD9-0DCB-4169-AF29-57A3A50B9109}" dt="2024-08-02T02:05:51.147" v="162" actId="1076"/>
          <ac:picMkLst>
            <pc:docMk/>
            <pc:sldMk cId="155154164" sldId="285"/>
            <ac:picMk id="42" creationId="{9E0E6D4E-8664-09C3-8B50-FF56E3D2D704}"/>
          </ac:picMkLst>
        </pc:picChg>
        <pc:picChg chg="add mod">
          <ac:chgData name="shaohua xie" userId="28ac0b58a72c0b90" providerId="LiveId" clId="{EE5ECFD9-0DCB-4169-AF29-57A3A50B9109}" dt="2024-08-02T02:05:49.691" v="161" actId="1076"/>
          <ac:picMkLst>
            <pc:docMk/>
            <pc:sldMk cId="155154164" sldId="285"/>
            <ac:picMk id="44" creationId="{745837D7-A136-FBDD-5195-471E41FD8FE5}"/>
          </ac:picMkLst>
        </pc:picChg>
        <pc:picChg chg="add mod">
          <ac:chgData name="shaohua xie" userId="28ac0b58a72c0b90" providerId="LiveId" clId="{EE5ECFD9-0DCB-4169-AF29-57A3A50B9109}" dt="2024-08-02T02:04:49.454" v="133" actId="1076"/>
          <ac:picMkLst>
            <pc:docMk/>
            <pc:sldMk cId="155154164" sldId="285"/>
            <ac:picMk id="46" creationId="{CE7F282F-612E-4D7D-2C5D-26E05D0C198A}"/>
          </ac:picMkLst>
        </pc:picChg>
        <pc:picChg chg="add mod">
          <ac:chgData name="shaohua xie" userId="28ac0b58a72c0b90" providerId="LiveId" clId="{EE5ECFD9-0DCB-4169-AF29-57A3A50B9109}" dt="2024-08-02T02:06:25.276" v="175" actId="1076"/>
          <ac:picMkLst>
            <pc:docMk/>
            <pc:sldMk cId="155154164" sldId="285"/>
            <ac:picMk id="48" creationId="{82F1A437-53DF-98FE-AA21-A7B547CA34E9}"/>
          </ac:picMkLst>
        </pc:picChg>
        <pc:picChg chg="add mod">
          <ac:chgData name="shaohua xie" userId="28ac0b58a72c0b90" providerId="LiveId" clId="{EE5ECFD9-0DCB-4169-AF29-57A3A50B9109}" dt="2024-08-02T02:07:04.164" v="185" actId="1076"/>
          <ac:picMkLst>
            <pc:docMk/>
            <pc:sldMk cId="155154164" sldId="285"/>
            <ac:picMk id="50" creationId="{C878B743-5F5D-CC6A-3810-E9BFE425DA9F}"/>
          </ac:picMkLst>
        </pc:picChg>
        <pc:picChg chg="add mod">
          <ac:chgData name="shaohua xie" userId="28ac0b58a72c0b90" providerId="LiveId" clId="{EE5ECFD9-0DCB-4169-AF29-57A3A50B9109}" dt="2024-08-02T02:06:49.748" v="178" actId="1076"/>
          <ac:picMkLst>
            <pc:docMk/>
            <pc:sldMk cId="155154164" sldId="285"/>
            <ac:picMk id="52" creationId="{FFFB0350-A154-2C6E-7225-B3BF5D76BD16}"/>
          </ac:picMkLst>
        </pc:picChg>
        <pc:picChg chg="add mod">
          <ac:chgData name="shaohua xie" userId="28ac0b58a72c0b90" providerId="LiveId" clId="{EE5ECFD9-0DCB-4169-AF29-57A3A50B9109}" dt="2024-08-02T02:07:07.860" v="186" actId="1076"/>
          <ac:picMkLst>
            <pc:docMk/>
            <pc:sldMk cId="155154164" sldId="285"/>
            <ac:picMk id="54" creationId="{08A64200-6437-C782-C38B-B31E8B7A5A8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56027" y="7541396"/>
            <a:ext cx="39168309" cy="16042793"/>
          </a:xfrm>
        </p:spPr>
        <p:txBody>
          <a:bodyPr anchor="b"/>
          <a:lstStyle>
            <a:lvl1pPr algn="ctr">
              <a:defRPr sz="30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60046" y="24202860"/>
            <a:ext cx="34560272" cy="11125418"/>
          </a:xfrm>
        </p:spPr>
        <p:txBody>
          <a:bodyPr/>
          <a:lstStyle>
            <a:lvl1pPr marL="0" indent="0" algn="ctr">
              <a:buNone/>
              <a:defRPr sz="12095"/>
            </a:lvl1pPr>
            <a:lvl2pPr marL="2304014" indent="0" algn="ctr">
              <a:buNone/>
              <a:defRPr sz="10079"/>
            </a:lvl2pPr>
            <a:lvl3pPr marL="4608027" indent="0" algn="ctr">
              <a:buNone/>
              <a:defRPr sz="9071"/>
            </a:lvl3pPr>
            <a:lvl4pPr marL="6912041" indent="0" algn="ctr">
              <a:buNone/>
              <a:defRPr sz="8063"/>
            </a:lvl4pPr>
            <a:lvl5pPr marL="9216055" indent="0" algn="ctr">
              <a:buNone/>
              <a:defRPr sz="8063"/>
            </a:lvl5pPr>
            <a:lvl6pPr marL="11520068" indent="0" algn="ctr">
              <a:buNone/>
              <a:defRPr sz="8063"/>
            </a:lvl6pPr>
            <a:lvl7pPr marL="13824082" indent="0" algn="ctr">
              <a:buNone/>
              <a:defRPr sz="8063"/>
            </a:lvl7pPr>
            <a:lvl8pPr marL="16128096" indent="0" algn="ctr">
              <a:buNone/>
              <a:defRPr sz="8063"/>
            </a:lvl8pPr>
            <a:lvl9pPr marL="18432109" indent="0" algn="ctr">
              <a:buNone/>
              <a:defRPr sz="806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957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764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976262" y="2453352"/>
            <a:ext cx="9936078" cy="3905097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68028" y="2453352"/>
            <a:ext cx="29232230" cy="3905097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649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47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4027" y="11488104"/>
            <a:ext cx="39744313" cy="19168148"/>
          </a:xfrm>
        </p:spPr>
        <p:txBody>
          <a:bodyPr anchor="b"/>
          <a:lstStyle>
            <a:lvl1pPr>
              <a:defRPr sz="30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4027" y="30837590"/>
            <a:ext cx="39744313" cy="10080076"/>
          </a:xfrm>
        </p:spPr>
        <p:txBody>
          <a:bodyPr/>
          <a:lstStyle>
            <a:lvl1pPr marL="0" indent="0">
              <a:buNone/>
              <a:defRPr sz="12095">
                <a:solidFill>
                  <a:schemeClr val="tx1"/>
                </a:solidFill>
              </a:defRPr>
            </a:lvl1pPr>
            <a:lvl2pPr marL="2304014" indent="0">
              <a:buNone/>
              <a:defRPr sz="10079">
                <a:solidFill>
                  <a:schemeClr val="tx1">
                    <a:tint val="75000"/>
                  </a:schemeClr>
                </a:solidFill>
              </a:defRPr>
            </a:lvl2pPr>
            <a:lvl3pPr marL="4608027" indent="0">
              <a:buNone/>
              <a:defRPr sz="9071">
                <a:solidFill>
                  <a:schemeClr val="tx1">
                    <a:tint val="75000"/>
                  </a:schemeClr>
                </a:solidFill>
              </a:defRPr>
            </a:lvl3pPr>
            <a:lvl4pPr marL="6912041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4pPr>
            <a:lvl5pPr marL="9216055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5pPr>
            <a:lvl6pPr marL="11520068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6pPr>
            <a:lvl7pPr marL="13824082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7pPr>
            <a:lvl8pPr marL="16128096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8pPr>
            <a:lvl9pPr marL="18432109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708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68025" y="12266763"/>
            <a:ext cx="19584154" cy="2923756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328184" y="12266763"/>
            <a:ext cx="19584154" cy="2923756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853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2453363"/>
            <a:ext cx="39744313" cy="890674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74032" y="11296092"/>
            <a:ext cx="19494150" cy="5536040"/>
          </a:xfrm>
        </p:spPr>
        <p:txBody>
          <a:bodyPr anchor="b"/>
          <a:lstStyle>
            <a:lvl1pPr marL="0" indent="0">
              <a:buNone/>
              <a:defRPr sz="12095" b="1"/>
            </a:lvl1pPr>
            <a:lvl2pPr marL="2304014" indent="0">
              <a:buNone/>
              <a:defRPr sz="10079" b="1"/>
            </a:lvl2pPr>
            <a:lvl3pPr marL="4608027" indent="0">
              <a:buNone/>
              <a:defRPr sz="9071" b="1"/>
            </a:lvl3pPr>
            <a:lvl4pPr marL="6912041" indent="0">
              <a:buNone/>
              <a:defRPr sz="8063" b="1"/>
            </a:lvl4pPr>
            <a:lvl5pPr marL="9216055" indent="0">
              <a:buNone/>
              <a:defRPr sz="8063" b="1"/>
            </a:lvl5pPr>
            <a:lvl6pPr marL="11520068" indent="0">
              <a:buNone/>
              <a:defRPr sz="8063" b="1"/>
            </a:lvl6pPr>
            <a:lvl7pPr marL="13824082" indent="0">
              <a:buNone/>
              <a:defRPr sz="8063" b="1"/>
            </a:lvl7pPr>
            <a:lvl8pPr marL="16128096" indent="0">
              <a:buNone/>
              <a:defRPr sz="8063" b="1"/>
            </a:lvl8pPr>
            <a:lvl9pPr marL="18432109" indent="0">
              <a:buNone/>
              <a:defRPr sz="806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4032" y="16832132"/>
            <a:ext cx="19494150" cy="247575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328186" y="11296092"/>
            <a:ext cx="19590156" cy="5536040"/>
          </a:xfrm>
        </p:spPr>
        <p:txBody>
          <a:bodyPr anchor="b"/>
          <a:lstStyle>
            <a:lvl1pPr marL="0" indent="0">
              <a:buNone/>
              <a:defRPr sz="12095" b="1"/>
            </a:lvl1pPr>
            <a:lvl2pPr marL="2304014" indent="0">
              <a:buNone/>
              <a:defRPr sz="10079" b="1"/>
            </a:lvl2pPr>
            <a:lvl3pPr marL="4608027" indent="0">
              <a:buNone/>
              <a:defRPr sz="9071" b="1"/>
            </a:lvl3pPr>
            <a:lvl4pPr marL="6912041" indent="0">
              <a:buNone/>
              <a:defRPr sz="8063" b="1"/>
            </a:lvl4pPr>
            <a:lvl5pPr marL="9216055" indent="0">
              <a:buNone/>
              <a:defRPr sz="8063" b="1"/>
            </a:lvl5pPr>
            <a:lvl6pPr marL="11520068" indent="0">
              <a:buNone/>
              <a:defRPr sz="8063" b="1"/>
            </a:lvl6pPr>
            <a:lvl7pPr marL="13824082" indent="0">
              <a:buNone/>
              <a:defRPr sz="8063" b="1"/>
            </a:lvl7pPr>
            <a:lvl8pPr marL="16128096" indent="0">
              <a:buNone/>
              <a:defRPr sz="8063" b="1"/>
            </a:lvl8pPr>
            <a:lvl9pPr marL="18432109" indent="0">
              <a:buNone/>
              <a:defRPr sz="806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328186" y="16832132"/>
            <a:ext cx="19590156" cy="247575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811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39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198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3072024"/>
            <a:ext cx="14862116" cy="10752085"/>
          </a:xfrm>
        </p:spPr>
        <p:txBody>
          <a:bodyPr anchor="b"/>
          <a:lstStyle>
            <a:lvl1pPr>
              <a:defRPr sz="1612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590156" y="6634729"/>
            <a:ext cx="23328184" cy="32746925"/>
          </a:xfrm>
        </p:spPr>
        <p:txBody>
          <a:bodyPr/>
          <a:lstStyle>
            <a:lvl1pPr>
              <a:defRPr sz="16126"/>
            </a:lvl1pPr>
            <a:lvl2pPr>
              <a:defRPr sz="14110"/>
            </a:lvl2pPr>
            <a:lvl3pPr>
              <a:defRPr sz="12095"/>
            </a:lvl3pPr>
            <a:lvl4pPr>
              <a:defRPr sz="10079"/>
            </a:lvl4pPr>
            <a:lvl5pPr>
              <a:defRPr sz="10079"/>
            </a:lvl5pPr>
            <a:lvl6pPr>
              <a:defRPr sz="10079"/>
            </a:lvl6pPr>
            <a:lvl7pPr>
              <a:defRPr sz="10079"/>
            </a:lvl7pPr>
            <a:lvl8pPr>
              <a:defRPr sz="10079"/>
            </a:lvl8pPr>
            <a:lvl9pPr>
              <a:defRPr sz="1007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74027" y="13824109"/>
            <a:ext cx="14862116" cy="25610872"/>
          </a:xfrm>
        </p:spPr>
        <p:txBody>
          <a:bodyPr/>
          <a:lstStyle>
            <a:lvl1pPr marL="0" indent="0">
              <a:buNone/>
              <a:defRPr sz="8063"/>
            </a:lvl1pPr>
            <a:lvl2pPr marL="2304014" indent="0">
              <a:buNone/>
              <a:defRPr sz="7055"/>
            </a:lvl2pPr>
            <a:lvl3pPr marL="4608027" indent="0">
              <a:buNone/>
              <a:defRPr sz="6047"/>
            </a:lvl3pPr>
            <a:lvl4pPr marL="6912041" indent="0">
              <a:buNone/>
              <a:defRPr sz="5039"/>
            </a:lvl4pPr>
            <a:lvl5pPr marL="9216055" indent="0">
              <a:buNone/>
              <a:defRPr sz="5039"/>
            </a:lvl5pPr>
            <a:lvl6pPr marL="11520068" indent="0">
              <a:buNone/>
              <a:defRPr sz="5039"/>
            </a:lvl6pPr>
            <a:lvl7pPr marL="13824082" indent="0">
              <a:buNone/>
              <a:defRPr sz="5039"/>
            </a:lvl7pPr>
            <a:lvl8pPr marL="16128096" indent="0">
              <a:buNone/>
              <a:defRPr sz="5039"/>
            </a:lvl8pPr>
            <a:lvl9pPr marL="18432109" indent="0">
              <a:buNone/>
              <a:defRPr sz="503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312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3072024"/>
            <a:ext cx="14862116" cy="10752085"/>
          </a:xfrm>
        </p:spPr>
        <p:txBody>
          <a:bodyPr anchor="b"/>
          <a:lstStyle>
            <a:lvl1pPr>
              <a:defRPr sz="1612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590156" y="6634729"/>
            <a:ext cx="23328184" cy="32746925"/>
          </a:xfrm>
        </p:spPr>
        <p:txBody>
          <a:bodyPr anchor="t"/>
          <a:lstStyle>
            <a:lvl1pPr marL="0" indent="0">
              <a:buNone/>
              <a:defRPr sz="16126"/>
            </a:lvl1pPr>
            <a:lvl2pPr marL="2304014" indent="0">
              <a:buNone/>
              <a:defRPr sz="14110"/>
            </a:lvl2pPr>
            <a:lvl3pPr marL="4608027" indent="0">
              <a:buNone/>
              <a:defRPr sz="12095"/>
            </a:lvl3pPr>
            <a:lvl4pPr marL="6912041" indent="0">
              <a:buNone/>
              <a:defRPr sz="10079"/>
            </a:lvl4pPr>
            <a:lvl5pPr marL="9216055" indent="0">
              <a:buNone/>
              <a:defRPr sz="10079"/>
            </a:lvl5pPr>
            <a:lvl6pPr marL="11520068" indent="0">
              <a:buNone/>
              <a:defRPr sz="10079"/>
            </a:lvl6pPr>
            <a:lvl7pPr marL="13824082" indent="0">
              <a:buNone/>
              <a:defRPr sz="10079"/>
            </a:lvl7pPr>
            <a:lvl8pPr marL="16128096" indent="0">
              <a:buNone/>
              <a:defRPr sz="10079"/>
            </a:lvl8pPr>
            <a:lvl9pPr marL="18432109" indent="0">
              <a:buNone/>
              <a:defRPr sz="1007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74027" y="13824109"/>
            <a:ext cx="14862116" cy="25610872"/>
          </a:xfrm>
        </p:spPr>
        <p:txBody>
          <a:bodyPr/>
          <a:lstStyle>
            <a:lvl1pPr marL="0" indent="0">
              <a:buNone/>
              <a:defRPr sz="8063"/>
            </a:lvl1pPr>
            <a:lvl2pPr marL="2304014" indent="0">
              <a:buNone/>
              <a:defRPr sz="7055"/>
            </a:lvl2pPr>
            <a:lvl3pPr marL="4608027" indent="0">
              <a:buNone/>
              <a:defRPr sz="6047"/>
            </a:lvl3pPr>
            <a:lvl4pPr marL="6912041" indent="0">
              <a:buNone/>
              <a:defRPr sz="5039"/>
            </a:lvl4pPr>
            <a:lvl5pPr marL="9216055" indent="0">
              <a:buNone/>
              <a:defRPr sz="5039"/>
            </a:lvl5pPr>
            <a:lvl6pPr marL="11520068" indent="0">
              <a:buNone/>
              <a:defRPr sz="5039"/>
            </a:lvl6pPr>
            <a:lvl7pPr marL="13824082" indent="0">
              <a:buNone/>
              <a:defRPr sz="5039"/>
            </a:lvl7pPr>
            <a:lvl8pPr marL="16128096" indent="0">
              <a:buNone/>
              <a:defRPr sz="5039"/>
            </a:lvl8pPr>
            <a:lvl9pPr marL="18432109" indent="0">
              <a:buNone/>
              <a:defRPr sz="503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56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68025" y="2453363"/>
            <a:ext cx="39744313" cy="89067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68025" y="12266763"/>
            <a:ext cx="39744313" cy="292375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68025" y="42709680"/>
            <a:ext cx="10368082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264120" y="42709680"/>
            <a:ext cx="15552123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544256" y="42709680"/>
            <a:ext cx="10368082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803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608027" rtl="0" eaLnBrk="1" latinLnBrk="0" hangingPunct="1">
        <a:lnSpc>
          <a:spcPct val="90000"/>
        </a:lnSpc>
        <a:spcBef>
          <a:spcPct val="0"/>
        </a:spcBef>
        <a:buNone/>
        <a:defRPr sz="221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52007" indent="-1152007" algn="l" defTabSz="4608027" rtl="0" eaLnBrk="1" latinLnBrk="0" hangingPunct="1">
        <a:lnSpc>
          <a:spcPct val="90000"/>
        </a:lnSpc>
        <a:spcBef>
          <a:spcPts val="5039"/>
        </a:spcBef>
        <a:buFont typeface="Arial" panose="020B0604020202020204" pitchFamily="34" charset="0"/>
        <a:buChar char="•"/>
        <a:defRPr sz="14110" kern="1200">
          <a:solidFill>
            <a:schemeClr val="tx1"/>
          </a:solidFill>
          <a:latin typeface="+mn-lt"/>
          <a:ea typeface="+mn-ea"/>
          <a:cs typeface="+mn-cs"/>
        </a:defRPr>
      </a:lvl1pPr>
      <a:lvl2pPr marL="3456021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12095" kern="1200">
          <a:solidFill>
            <a:schemeClr val="tx1"/>
          </a:solidFill>
          <a:latin typeface="+mn-lt"/>
          <a:ea typeface="+mn-ea"/>
          <a:cs typeface="+mn-cs"/>
        </a:defRPr>
      </a:lvl2pPr>
      <a:lvl3pPr marL="5760034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10079" kern="1200">
          <a:solidFill>
            <a:schemeClr val="tx1"/>
          </a:solidFill>
          <a:latin typeface="+mn-lt"/>
          <a:ea typeface="+mn-ea"/>
          <a:cs typeface="+mn-cs"/>
        </a:defRPr>
      </a:lvl3pPr>
      <a:lvl4pPr marL="8064048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4pPr>
      <a:lvl5pPr marL="10368062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5pPr>
      <a:lvl6pPr marL="12672075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6pPr>
      <a:lvl7pPr marL="14976089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7pPr>
      <a:lvl8pPr marL="17280103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8pPr>
      <a:lvl9pPr marL="19584116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1pPr>
      <a:lvl2pPr marL="2304014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2pPr>
      <a:lvl3pPr marL="4608027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3pPr>
      <a:lvl4pPr marL="6912041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4pPr>
      <a:lvl5pPr marL="9216055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5pPr>
      <a:lvl6pPr marL="11520068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6pPr>
      <a:lvl7pPr marL="13824082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7pPr>
      <a:lvl8pPr marL="16128096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8pPr>
      <a:lvl9pPr marL="18432109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7840608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c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3CC9F615-EA8A-4694-52B4-8E566BC6BD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16103" y="20991004"/>
            <a:ext cx="8840124" cy="9768335"/>
          </a:xfrm>
          <a:prstGeom prst="rect">
            <a:avLst/>
          </a:prstGeom>
        </p:spPr>
      </p:pic>
      <p:pic>
        <p:nvPicPr>
          <p:cNvPr id="15" name="Picture 14" descr="A picture containing text, blurry, white&#10;&#10;Description automatically generated">
            <a:extLst>
              <a:ext uri="{FF2B5EF4-FFF2-40B4-BE49-F238E27FC236}">
                <a16:creationId xmlns:a16="http://schemas.microsoft.com/office/drawing/2014/main" id="{1B7A70ED-3347-1187-019E-7BB96464E9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52134" y="11161932"/>
            <a:ext cx="8840124" cy="9768335"/>
          </a:xfrm>
          <a:prstGeom prst="rect">
            <a:avLst/>
          </a:prstGeom>
        </p:spPr>
      </p:pic>
      <p:pic>
        <p:nvPicPr>
          <p:cNvPr id="16" name="Picture 15" descr="A picture containing indoor, close, vegetable&#10;&#10;Description automatically generated">
            <a:extLst>
              <a:ext uri="{FF2B5EF4-FFF2-40B4-BE49-F238E27FC236}">
                <a16:creationId xmlns:a16="http://schemas.microsoft.com/office/drawing/2014/main" id="{08BD2A26-C93A-7CDF-C81F-AD0A6D61792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" y="11208007"/>
            <a:ext cx="18890981" cy="19536669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188D2918-C60D-6A00-AF85-7C778E01FB22}"/>
              </a:ext>
            </a:extLst>
          </p:cNvPr>
          <p:cNvSpPr/>
          <p:nvPr/>
        </p:nvSpPr>
        <p:spPr>
          <a:xfrm>
            <a:off x="5431987" y="16695287"/>
            <a:ext cx="8020119" cy="8128977"/>
          </a:xfrm>
          <a:prstGeom prst="rect">
            <a:avLst/>
          </a:prstGeom>
          <a:noFill/>
          <a:ln w="127000" cap="flat" cmpd="sng" algn="ctr">
            <a:solidFill>
              <a:srgbClr val="FFCC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60C45A2-FDEE-05C9-06A0-F81881D32C60}"/>
              </a:ext>
            </a:extLst>
          </p:cNvPr>
          <p:cNvGrpSpPr/>
          <p:nvPr/>
        </p:nvGrpSpPr>
        <p:grpSpPr>
          <a:xfrm>
            <a:off x="19163484" y="21022416"/>
            <a:ext cx="8840124" cy="9768335"/>
            <a:chOff x="5379101" y="1164384"/>
            <a:chExt cx="1655023" cy="1828800"/>
          </a:xfrm>
        </p:grpSpPr>
        <p:pic>
          <p:nvPicPr>
            <p:cNvPr id="27" name="Picture 26" descr="Background pattern&#10;&#10;Description automatically generated with low confidence">
              <a:extLst>
                <a:ext uri="{FF2B5EF4-FFF2-40B4-BE49-F238E27FC236}">
                  <a16:creationId xmlns:a16="http://schemas.microsoft.com/office/drawing/2014/main" id="{5D9F72AA-4D04-D4C5-80CB-CBA29EF3E6E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79101" y="1164384"/>
              <a:ext cx="1655023" cy="182880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FD8BAEA-C369-CDA1-41B9-659D6ACA8737}"/>
                </a:ext>
              </a:extLst>
            </p:cNvPr>
            <p:cNvSpPr txBox="1"/>
            <p:nvPr/>
          </p:nvSpPr>
          <p:spPr>
            <a:xfrm>
              <a:off x="6728601" y="1173341"/>
              <a:ext cx="169022" cy="224722"/>
            </a:xfrm>
            <a:prstGeom prst="rect">
              <a:avLst/>
            </a:prstGeom>
            <a:solidFill>
              <a:sysClr val="windowText" lastClr="000000"/>
            </a:solidFill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2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3987FA4-3C28-8FD4-A158-BEB4B434CC8E}"/>
              </a:ext>
            </a:extLst>
          </p:cNvPr>
          <p:cNvGrpSpPr/>
          <p:nvPr/>
        </p:nvGrpSpPr>
        <p:grpSpPr>
          <a:xfrm>
            <a:off x="28101724" y="11144284"/>
            <a:ext cx="8840124" cy="9768335"/>
            <a:chOff x="3706826" y="3014840"/>
            <a:chExt cx="1655023" cy="1828800"/>
          </a:xfrm>
        </p:grpSpPr>
        <p:pic>
          <p:nvPicPr>
            <p:cNvPr id="25" name="Picture 24" descr="A picture containing text, night sky&#10;&#10;Description automatically generated">
              <a:extLst>
                <a:ext uri="{FF2B5EF4-FFF2-40B4-BE49-F238E27FC236}">
                  <a16:creationId xmlns:a16="http://schemas.microsoft.com/office/drawing/2014/main" id="{2789A3DD-CA87-3B78-AAE4-7A8B8AABCD1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6826" y="3014840"/>
              <a:ext cx="1655023" cy="182880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45F2BBD-E96C-887E-43FC-D88000A89B30}"/>
                </a:ext>
              </a:extLst>
            </p:cNvPr>
            <p:cNvSpPr txBox="1"/>
            <p:nvPr/>
          </p:nvSpPr>
          <p:spPr>
            <a:xfrm>
              <a:off x="5034046" y="3019061"/>
              <a:ext cx="188229" cy="224722"/>
            </a:xfrm>
            <a:prstGeom prst="rect">
              <a:avLst/>
            </a:prstGeom>
            <a:solidFill>
              <a:sysClr val="windowText" lastClr="000000"/>
            </a:solidFill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2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kumimoji="0" lang="en-US" altLang="zh-CN" sz="72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kumimoji="0" lang="en-US" sz="7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BF50DC1-56C8-B5D9-3209-46E77801F577}"/>
              </a:ext>
            </a:extLst>
          </p:cNvPr>
          <p:cNvSpPr txBox="1"/>
          <p:nvPr/>
        </p:nvSpPr>
        <p:spPr>
          <a:xfrm>
            <a:off x="35127533" y="21044962"/>
            <a:ext cx="1107996" cy="1200329"/>
          </a:xfrm>
          <a:prstGeom prst="rect">
            <a:avLst/>
          </a:prstGeom>
          <a:solidFill>
            <a:sysClr val="windowText" lastClr="000000"/>
          </a:solidFill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</a:p>
        </p:txBody>
      </p:sp>
      <p:pic>
        <p:nvPicPr>
          <p:cNvPr id="21" name="Picture 20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C68683BC-1EB2-F50F-A493-B2042E3CF4D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62756" y="11161932"/>
            <a:ext cx="8840124" cy="9768335"/>
          </a:xfrm>
          <a:prstGeom prst="rect">
            <a:avLst/>
          </a:prstGeom>
        </p:spPr>
      </p:pic>
      <p:pic>
        <p:nvPicPr>
          <p:cNvPr id="22" name="Picture 21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E6DD524C-2438-5A35-695D-9E18DE75201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33998" y="21022416"/>
            <a:ext cx="8840124" cy="976833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00A085D-7125-B4E5-1DFD-98B5DEB1C18A}"/>
              </a:ext>
            </a:extLst>
          </p:cNvPr>
          <p:cNvSpPr txBox="1"/>
          <p:nvPr/>
        </p:nvSpPr>
        <p:spPr>
          <a:xfrm>
            <a:off x="44106496" y="11190359"/>
            <a:ext cx="1056700" cy="1200329"/>
          </a:xfrm>
          <a:prstGeom prst="rect">
            <a:avLst/>
          </a:prstGeom>
          <a:solidFill>
            <a:sysClr val="windowText" lastClr="000000"/>
          </a:solidFill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DB0608E-EA04-62BB-9459-9D57B2796F23}"/>
              </a:ext>
            </a:extLst>
          </p:cNvPr>
          <p:cNvSpPr txBox="1"/>
          <p:nvPr/>
        </p:nvSpPr>
        <p:spPr>
          <a:xfrm>
            <a:off x="44079639" y="21049070"/>
            <a:ext cx="1107996" cy="1200329"/>
          </a:xfrm>
          <a:prstGeom prst="rect">
            <a:avLst/>
          </a:prstGeom>
          <a:solidFill>
            <a:sysClr val="windowText" lastClr="000000"/>
          </a:solidFill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</a:p>
        </p:txBody>
      </p:sp>
    </p:spTree>
    <p:extLst>
      <p:ext uri="{BB962C8B-B14F-4D97-AF65-F5344CB8AC3E}">
        <p14:creationId xmlns:p14="http://schemas.microsoft.com/office/powerpoint/2010/main" val="2327992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本框 57">
            <a:extLst>
              <a:ext uri="{FF2B5EF4-FFF2-40B4-BE49-F238E27FC236}">
                <a16:creationId xmlns:a16="http://schemas.microsoft.com/office/drawing/2014/main" id="{F10F1FD5-5BB2-276E-5354-9E96B4B5698C}"/>
              </a:ext>
            </a:extLst>
          </p:cNvPr>
          <p:cNvSpPr txBox="1"/>
          <p:nvPr/>
        </p:nvSpPr>
        <p:spPr>
          <a:xfrm>
            <a:off x="2704864" y="1564703"/>
            <a:ext cx="34360688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5a inserted configurations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 descr="A group of spheres with red and blue dots&#10;&#10;Description automatically generated">
            <a:extLst>
              <a:ext uri="{FF2B5EF4-FFF2-40B4-BE49-F238E27FC236}">
                <a16:creationId xmlns:a16="http://schemas.microsoft.com/office/drawing/2014/main" id="{53EDFE5C-A514-AF9F-73F4-E8672A2D69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3091" y="15160605"/>
            <a:ext cx="18288000" cy="15611710"/>
          </a:xfrm>
          <a:prstGeom prst="rect">
            <a:avLst/>
          </a:prstGeom>
        </p:spPr>
      </p:pic>
      <p:pic>
        <p:nvPicPr>
          <p:cNvPr id="9" name="Picture 8" descr="A close-up of a molecule&#10;&#10;Description automatically generated">
            <a:extLst>
              <a:ext uri="{FF2B5EF4-FFF2-40B4-BE49-F238E27FC236}">
                <a16:creationId xmlns:a16="http://schemas.microsoft.com/office/drawing/2014/main" id="{E3F15F24-59FD-4E59-FADA-5A563449C5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16664" y="15194996"/>
            <a:ext cx="18288000" cy="1572126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B79C7D8-ACA7-7FA6-12A6-9F05773767D1}"/>
              </a:ext>
            </a:extLst>
          </p:cNvPr>
          <p:cNvSpPr txBox="1"/>
          <p:nvPr/>
        </p:nvSpPr>
        <p:spPr>
          <a:xfrm>
            <a:off x="3016350" y="11131270"/>
            <a:ext cx="1716141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4 NO adsorption on H</a:t>
            </a:r>
            <a:r>
              <a:rPr lang="en-US" sz="12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O/Pt (111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144F6C-EEB4-7B79-2336-D5CF3DC91C96}"/>
              </a:ext>
            </a:extLst>
          </p:cNvPr>
          <p:cNvSpPr txBox="1"/>
          <p:nvPr/>
        </p:nvSpPr>
        <p:spPr>
          <a:xfrm>
            <a:off x="25571550" y="11131270"/>
            <a:ext cx="1545453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7 NO adsorption on Pt (111)</a:t>
            </a:r>
          </a:p>
        </p:txBody>
      </p:sp>
    </p:spTree>
    <p:extLst>
      <p:ext uri="{BB962C8B-B14F-4D97-AF65-F5344CB8AC3E}">
        <p14:creationId xmlns:p14="http://schemas.microsoft.com/office/powerpoint/2010/main" val="574296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本框 57">
            <a:extLst>
              <a:ext uri="{FF2B5EF4-FFF2-40B4-BE49-F238E27FC236}">
                <a16:creationId xmlns:a16="http://schemas.microsoft.com/office/drawing/2014/main" id="{F10F1FD5-5BB2-276E-5354-9E96B4B5698C}"/>
              </a:ext>
            </a:extLst>
          </p:cNvPr>
          <p:cNvSpPr txBox="1"/>
          <p:nvPr/>
        </p:nvSpPr>
        <p:spPr>
          <a:xfrm>
            <a:off x="2704864" y="1564703"/>
            <a:ext cx="34360688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5b inserted configurations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A group of white spheres with red and yellow dots&#10;&#10;Description automatically generated">
            <a:extLst>
              <a:ext uri="{FF2B5EF4-FFF2-40B4-BE49-F238E27FC236}">
                <a16:creationId xmlns:a16="http://schemas.microsoft.com/office/drawing/2014/main" id="{39D80FD3-3706-3EBD-1D50-6FDA1CD290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37378" y="27691080"/>
            <a:ext cx="18288000" cy="15611704"/>
          </a:xfrm>
          <a:prstGeom prst="rect">
            <a:avLst/>
          </a:prstGeom>
        </p:spPr>
      </p:pic>
      <p:pic>
        <p:nvPicPr>
          <p:cNvPr id="3" name="Picture 2" descr="A group of white spheres with red and yellow spheres&#10;&#10;Description automatically generated">
            <a:extLst>
              <a:ext uri="{FF2B5EF4-FFF2-40B4-BE49-F238E27FC236}">
                <a16:creationId xmlns:a16="http://schemas.microsoft.com/office/drawing/2014/main" id="{FDD3ACE2-C3A1-A57A-159C-E5B811EC01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1976" y="27691080"/>
            <a:ext cx="18288000" cy="15611704"/>
          </a:xfrm>
          <a:prstGeom prst="rect">
            <a:avLst/>
          </a:prstGeom>
        </p:spPr>
      </p:pic>
      <p:pic>
        <p:nvPicPr>
          <p:cNvPr id="4" name="Picture 3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64648A34-F195-0134-F239-5B5FEE0D67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110754" y="7617460"/>
            <a:ext cx="18288000" cy="156439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9178384-B911-A065-2D2E-19BDF5AB99BD}"/>
              </a:ext>
            </a:extLst>
          </p:cNvPr>
          <p:cNvSpPr txBox="1"/>
          <p:nvPr/>
        </p:nvSpPr>
        <p:spPr>
          <a:xfrm>
            <a:off x="13745310" y="5157190"/>
            <a:ext cx="1716141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7 NO/Pt (111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3D637D-E13A-66CC-C00B-B7E9CCDFCFE4}"/>
              </a:ext>
            </a:extLst>
          </p:cNvPr>
          <p:cNvSpPr txBox="1"/>
          <p:nvPr/>
        </p:nvSpPr>
        <p:spPr>
          <a:xfrm>
            <a:off x="3199230" y="25273990"/>
            <a:ext cx="1716141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O/Pt (11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2501224-58A5-C3A9-A1C8-D6920767A5D9}"/>
              </a:ext>
            </a:extLst>
          </p:cNvPr>
          <p:cNvSpPr txBox="1"/>
          <p:nvPr/>
        </p:nvSpPr>
        <p:spPr>
          <a:xfrm>
            <a:off x="25876350" y="25030150"/>
            <a:ext cx="1716141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0" b="1" dirty="0">
                <a:latin typeface="Arial" panose="020B0604020202020204" pitchFamily="34" charset="0"/>
                <a:cs typeface="Arial" panose="020B0604020202020204" pitchFamily="34" charset="0"/>
              </a:rPr>
              <a:t>O/Pt (111)    2*</a:t>
            </a:r>
            <a:r>
              <a:rPr lang="en-US" sz="12000" b="1" dirty="0" err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endParaRPr lang="en-US" sz="120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80302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E2C711A-C068-99BA-ABC6-0415A1D76BBB}"/>
              </a:ext>
            </a:extLst>
          </p:cNvPr>
          <p:cNvSpPr txBox="1"/>
          <p:nvPr/>
        </p:nvSpPr>
        <p:spPr>
          <a:xfrm>
            <a:off x="2704864" y="1564703"/>
            <a:ext cx="6564618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6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 descr="A group of white balls with red and yellow dots&#10;&#10;Description automatically generated">
            <a:extLst>
              <a:ext uri="{FF2B5EF4-FFF2-40B4-BE49-F238E27FC236}">
                <a16:creationId xmlns:a16="http://schemas.microsoft.com/office/drawing/2014/main" id="{59C89845-798A-09B2-636D-96C5703723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7215" y="8470740"/>
            <a:ext cx="7315200" cy="7298613"/>
          </a:xfrm>
          <a:prstGeom prst="rect">
            <a:avLst/>
          </a:prstGeom>
        </p:spPr>
      </p:pic>
      <p:pic>
        <p:nvPicPr>
          <p:cNvPr id="32" name="Picture 31" descr="A group of white balls with red and yellow dots&#10;&#10;Description automatically generated">
            <a:extLst>
              <a:ext uri="{FF2B5EF4-FFF2-40B4-BE49-F238E27FC236}">
                <a16:creationId xmlns:a16="http://schemas.microsoft.com/office/drawing/2014/main" id="{9B2A621F-3E85-25C9-B902-EAD3B60614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3299" y="8287859"/>
            <a:ext cx="7315200" cy="7315200"/>
          </a:xfrm>
          <a:prstGeom prst="rect">
            <a:avLst/>
          </a:prstGeom>
        </p:spPr>
      </p:pic>
      <p:pic>
        <p:nvPicPr>
          <p:cNvPr id="34" name="Picture 33" descr="A group of white balls with red and blue dots&#10;&#10;Description automatically generated">
            <a:extLst>
              <a:ext uri="{FF2B5EF4-FFF2-40B4-BE49-F238E27FC236}">
                <a16:creationId xmlns:a16="http://schemas.microsoft.com/office/drawing/2014/main" id="{6565FAF1-CE6E-8BE4-BC0B-BE8F300850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1699" y="8348819"/>
            <a:ext cx="7315200" cy="7315200"/>
          </a:xfrm>
          <a:prstGeom prst="rect">
            <a:avLst/>
          </a:prstGeom>
        </p:spPr>
      </p:pic>
      <p:pic>
        <p:nvPicPr>
          <p:cNvPr id="36" name="Picture 35" descr="A circular object with red and blue balls&#10;&#10;Description automatically generated">
            <a:extLst>
              <a:ext uri="{FF2B5EF4-FFF2-40B4-BE49-F238E27FC236}">
                <a16:creationId xmlns:a16="http://schemas.microsoft.com/office/drawing/2014/main" id="{09F7F587-008D-95B1-B0EB-5F891939A2E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08179" y="8165939"/>
            <a:ext cx="7315200" cy="7315200"/>
          </a:xfrm>
          <a:prstGeom prst="rect">
            <a:avLst/>
          </a:prstGeom>
        </p:spPr>
      </p:pic>
      <p:pic>
        <p:nvPicPr>
          <p:cNvPr id="38" name="Picture 37" descr="A circular object with red and blue balls&#10;&#10;Description automatically generated">
            <a:extLst>
              <a:ext uri="{FF2B5EF4-FFF2-40B4-BE49-F238E27FC236}">
                <a16:creationId xmlns:a16="http://schemas.microsoft.com/office/drawing/2014/main" id="{DC141AD5-E514-BE6E-093D-972466DE85C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9699" y="18285299"/>
            <a:ext cx="7315200" cy="7315200"/>
          </a:xfrm>
          <a:prstGeom prst="rect">
            <a:avLst/>
          </a:prstGeom>
        </p:spPr>
      </p:pic>
      <p:pic>
        <p:nvPicPr>
          <p:cNvPr id="40" name="Picture 39" descr="A close-up of a sphere&#10;&#10;Description automatically generated">
            <a:extLst>
              <a:ext uri="{FF2B5EF4-FFF2-40B4-BE49-F238E27FC236}">
                <a16:creationId xmlns:a16="http://schemas.microsoft.com/office/drawing/2014/main" id="{B5603011-795A-5166-B749-B4EAF70DB51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18099" y="18163379"/>
            <a:ext cx="7315200" cy="7315200"/>
          </a:xfrm>
          <a:prstGeom prst="rect">
            <a:avLst/>
          </a:prstGeom>
        </p:spPr>
      </p:pic>
      <p:pic>
        <p:nvPicPr>
          <p:cNvPr id="42" name="Picture 41" descr="A circular object with many spheres&#10;&#10;Description automatically generated">
            <a:extLst>
              <a:ext uri="{FF2B5EF4-FFF2-40B4-BE49-F238E27FC236}">
                <a16:creationId xmlns:a16="http://schemas.microsoft.com/office/drawing/2014/main" id="{9E0E6D4E-8664-09C3-8B50-FF56E3D2D70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76499" y="18285299"/>
            <a:ext cx="7315200" cy="7315200"/>
          </a:xfrm>
          <a:prstGeom prst="rect">
            <a:avLst/>
          </a:prstGeom>
        </p:spPr>
      </p:pic>
      <p:pic>
        <p:nvPicPr>
          <p:cNvPr id="44" name="Picture 43" descr="A circular object with many spheres&#10;&#10;Description automatically generated">
            <a:extLst>
              <a:ext uri="{FF2B5EF4-FFF2-40B4-BE49-F238E27FC236}">
                <a16:creationId xmlns:a16="http://schemas.microsoft.com/office/drawing/2014/main" id="{745837D7-A136-FBDD-5195-471E41FD8FE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15083" y="18163379"/>
            <a:ext cx="7315200" cy="7315200"/>
          </a:xfrm>
          <a:prstGeom prst="rect">
            <a:avLst/>
          </a:prstGeom>
        </p:spPr>
      </p:pic>
      <p:pic>
        <p:nvPicPr>
          <p:cNvPr id="46" name="Picture 45" descr="A circular object with red and blue balls&#10;&#10;Description automatically generated">
            <a:extLst>
              <a:ext uri="{FF2B5EF4-FFF2-40B4-BE49-F238E27FC236}">
                <a16:creationId xmlns:a16="http://schemas.microsoft.com/office/drawing/2014/main" id="{CE7F282F-612E-4D7D-2C5D-26E05D0C198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320" y="27795059"/>
            <a:ext cx="7315200" cy="7315200"/>
          </a:xfrm>
          <a:prstGeom prst="rect">
            <a:avLst/>
          </a:prstGeom>
        </p:spPr>
      </p:pic>
      <p:pic>
        <p:nvPicPr>
          <p:cNvPr id="48" name="Picture 47" descr="A circular object with red and blue spheres&#10;&#10;Description automatically generated">
            <a:extLst>
              <a:ext uri="{FF2B5EF4-FFF2-40B4-BE49-F238E27FC236}">
                <a16:creationId xmlns:a16="http://schemas.microsoft.com/office/drawing/2014/main" id="{82F1A437-53DF-98FE-AA21-A7B547CA34E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05779" y="27795059"/>
            <a:ext cx="7315200" cy="7315200"/>
          </a:xfrm>
          <a:prstGeom prst="rect">
            <a:avLst/>
          </a:prstGeom>
        </p:spPr>
      </p:pic>
      <p:pic>
        <p:nvPicPr>
          <p:cNvPr id="50" name="Picture 49" descr="A close-up of a circle of spheres&#10;&#10;Description automatically generated">
            <a:extLst>
              <a:ext uri="{FF2B5EF4-FFF2-40B4-BE49-F238E27FC236}">
                <a16:creationId xmlns:a16="http://schemas.microsoft.com/office/drawing/2014/main" id="{C878B743-5F5D-CC6A-3810-E9BFE425DA9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2259" y="27916979"/>
            <a:ext cx="7315200" cy="7315200"/>
          </a:xfrm>
          <a:prstGeom prst="rect">
            <a:avLst/>
          </a:prstGeom>
        </p:spPr>
      </p:pic>
      <p:pic>
        <p:nvPicPr>
          <p:cNvPr id="52" name="Picture 51" descr="A circular object with red and blue balls&#10;&#10;Description automatically generated">
            <a:extLst>
              <a:ext uri="{FF2B5EF4-FFF2-40B4-BE49-F238E27FC236}">
                <a16:creationId xmlns:a16="http://schemas.microsoft.com/office/drawing/2014/main" id="{FFFB0350-A154-2C6E-7225-B3BF5D76BD1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05459" y="27673139"/>
            <a:ext cx="7315200" cy="7315200"/>
          </a:xfrm>
          <a:prstGeom prst="rect">
            <a:avLst/>
          </a:prstGeom>
        </p:spPr>
      </p:pic>
      <p:pic>
        <p:nvPicPr>
          <p:cNvPr id="54" name="Picture 53" descr="A circular object with red and yellow balls&#10;&#10;Description automatically generated">
            <a:extLst>
              <a:ext uri="{FF2B5EF4-FFF2-40B4-BE49-F238E27FC236}">
                <a16:creationId xmlns:a16="http://schemas.microsoft.com/office/drawing/2014/main" id="{08A64200-6437-C782-C38B-B31E8B7A5A8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4499" y="37119243"/>
            <a:ext cx="7315200" cy="731520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E92D88DA-EFB0-4CE6-5480-226E5B2563D8}"/>
              </a:ext>
            </a:extLst>
          </p:cNvPr>
          <p:cNvSpPr txBox="1"/>
          <p:nvPr/>
        </p:nvSpPr>
        <p:spPr>
          <a:xfrm>
            <a:off x="6522721" y="649830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0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5E94D7C-6B51-A7DC-4722-7CA1888F11F5}"/>
              </a:ext>
            </a:extLst>
          </p:cNvPr>
          <p:cNvSpPr txBox="1"/>
          <p:nvPr/>
        </p:nvSpPr>
        <p:spPr>
          <a:xfrm>
            <a:off x="16276321" y="649830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83F71FA-1B5F-B4C4-B9CA-6E55E8BDA723}"/>
              </a:ext>
            </a:extLst>
          </p:cNvPr>
          <p:cNvSpPr txBox="1"/>
          <p:nvPr/>
        </p:nvSpPr>
        <p:spPr>
          <a:xfrm>
            <a:off x="26212801" y="649830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F9FBC9C-1734-C5C8-5641-47392F9946D9}"/>
              </a:ext>
            </a:extLst>
          </p:cNvPr>
          <p:cNvSpPr txBox="1"/>
          <p:nvPr/>
        </p:nvSpPr>
        <p:spPr>
          <a:xfrm>
            <a:off x="36210241" y="631542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3D5846B-2193-4B55-6A18-190B96ADD754}"/>
              </a:ext>
            </a:extLst>
          </p:cNvPr>
          <p:cNvSpPr txBox="1"/>
          <p:nvPr/>
        </p:nvSpPr>
        <p:spPr>
          <a:xfrm>
            <a:off x="6644641" y="1643478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ADBDF15-F3DE-5361-A442-59817ADAD9DA}"/>
              </a:ext>
            </a:extLst>
          </p:cNvPr>
          <p:cNvSpPr txBox="1"/>
          <p:nvPr/>
        </p:nvSpPr>
        <p:spPr>
          <a:xfrm>
            <a:off x="16581121" y="1649574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10B6007-A193-D650-E802-66F30A7529DE}"/>
              </a:ext>
            </a:extLst>
          </p:cNvPr>
          <p:cNvSpPr txBox="1"/>
          <p:nvPr/>
        </p:nvSpPr>
        <p:spPr>
          <a:xfrm>
            <a:off x="26578561" y="1655670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i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05D8703-F104-3550-9D4E-1755C13E7584}"/>
              </a:ext>
            </a:extLst>
          </p:cNvPr>
          <p:cNvSpPr txBox="1"/>
          <p:nvPr/>
        </p:nvSpPr>
        <p:spPr>
          <a:xfrm>
            <a:off x="36636961" y="1649574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ii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3AE4E67-DFA7-4346-7F5A-4DAB9C53BFCB}"/>
              </a:ext>
            </a:extLst>
          </p:cNvPr>
          <p:cNvSpPr txBox="1"/>
          <p:nvPr/>
        </p:nvSpPr>
        <p:spPr>
          <a:xfrm>
            <a:off x="6705601" y="2606646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x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D098C75-C31D-9732-6B2A-ACCB4BB65175}"/>
              </a:ext>
            </a:extLst>
          </p:cNvPr>
          <p:cNvSpPr txBox="1"/>
          <p:nvPr/>
        </p:nvSpPr>
        <p:spPr>
          <a:xfrm>
            <a:off x="17129761" y="25908000"/>
            <a:ext cx="152399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B6E9903-5DB7-CF6F-990B-3D846F6D9970}"/>
              </a:ext>
            </a:extLst>
          </p:cNvPr>
          <p:cNvSpPr txBox="1"/>
          <p:nvPr/>
        </p:nvSpPr>
        <p:spPr>
          <a:xfrm>
            <a:off x="26883361" y="2606646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xi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AEAA197-DFEC-337A-DD4B-59F01241F8A3}"/>
              </a:ext>
            </a:extLst>
          </p:cNvPr>
          <p:cNvSpPr txBox="1"/>
          <p:nvPr/>
        </p:nvSpPr>
        <p:spPr>
          <a:xfrm>
            <a:off x="36758881" y="2600550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xii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485AFCB-FAA2-931A-767B-39C1782AAC96}"/>
              </a:ext>
            </a:extLst>
          </p:cNvPr>
          <p:cNvSpPr txBox="1"/>
          <p:nvPr/>
        </p:nvSpPr>
        <p:spPr>
          <a:xfrm>
            <a:off x="22006561" y="35332389"/>
            <a:ext cx="20726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xiii</a:t>
            </a:r>
          </a:p>
        </p:txBody>
      </p:sp>
    </p:spTree>
    <p:extLst>
      <p:ext uri="{BB962C8B-B14F-4D97-AF65-F5344CB8AC3E}">
        <p14:creationId xmlns:p14="http://schemas.microsoft.com/office/powerpoint/2010/main" val="155154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25</TotalTime>
  <Words>74</Words>
  <Application>Microsoft Office PowerPoint</Application>
  <PresentationFormat>Custom</PresentationFormat>
  <Paragraphs>2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 Tan</dc:creator>
  <cp:lastModifiedBy>Shaohua Xie</cp:lastModifiedBy>
  <cp:revision>104</cp:revision>
  <dcterms:created xsi:type="dcterms:W3CDTF">2022-09-18T17:24:10Z</dcterms:created>
  <dcterms:modified xsi:type="dcterms:W3CDTF">2024-08-02T02:07:16Z</dcterms:modified>
</cp:coreProperties>
</file>